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4401800" cy="12601575"/>
  <p:notesSz cx="6858000" cy="9144000"/>
  <p:defaultTextStyle>
    <a:defPPr>
      <a:defRPr lang="de-DE"/>
    </a:defPPr>
    <a:lvl1pPr marL="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1pPr>
    <a:lvl2pPr marL="771525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2pPr>
    <a:lvl3pPr marL="154305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3pPr>
    <a:lvl4pPr marL="2314575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4pPr>
    <a:lvl5pPr marL="308610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5pPr>
    <a:lvl6pPr marL="3857625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6pPr>
    <a:lvl7pPr marL="462915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7pPr>
    <a:lvl8pPr marL="5400675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8pPr>
    <a:lvl9pPr marL="617220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969">
          <p15:clr>
            <a:srgbClr val="A4A3A4"/>
          </p15:clr>
        </p15:guide>
        <p15:guide id="2" pos="453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8600B58-B2E9-4E2C-A90B-BCD813464593}" v="22" dt="2024-02-26T00:47:44.3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2574" y="-492"/>
      </p:cViewPr>
      <p:guideLst>
        <p:guide orient="horz" pos="3969"/>
        <p:guide pos="45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ominik Aumann" userId="013c187a20e8f01a" providerId="LiveId" clId="{08600B58-B2E9-4E2C-A90B-BCD813464593}"/>
    <pc:docChg chg="undo custSel addSld delSld modSld sldOrd">
      <pc:chgData name="Dominik Aumann" userId="013c187a20e8f01a" providerId="LiveId" clId="{08600B58-B2E9-4E2C-A90B-BCD813464593}" dt="2024-02-26T00:50:54.833" v="145" actId="1037"/>
      <pc:docMkLst>
        <pc:docMk/>
      </pc:docMkLst>
      <pc:sldChg chg="addSp delSp modSp mod">
        <pc:chgData name="Dominik Aumann" userId="013c187a20e8f01a" providerId="LiveId" clId="{08600B58-B2E9-4E2C-A90B-BCD813464593}" dt="2024-02-26T00:50:54.833" v="145" actId="1037"/>
        <pc:sldMkLst>
          <pc:docMk/>
          <pc:sldMk cId="3452512847" sldId="256"/>
        </pc:sldMkLst>
        <pc:picChg chg="add del mod">
          <ac:chgData name="Dominik Aumann" userId="013c187a20e8f01a" providerId="LiveId" clId="{08600B58-B2E9-4E2C-A90B-BCD813464593}" dt="2024-02-26T00:46:54.157" v="61" actId="478"/>
          <ac:picMkLst>
            <pc:docMk/>
            <pc:sldMk cId="3452512847" sldId="256"/>
            <ac:picMk id="8" creationId="{00000000-0000-0000-0000-000000000000}"/>
          </ac:picMkLst>
        </pc:picChg>
        <pc:picChg chg="add mod">
          <ac:chgData name="Dominik Aumann" userId="013c187a20e8f01a" providerId="LiveId" clId="{08600B58-B2E9-4E2C-A90B-BCD813464593}" dt="2024-02-26T00:45:21.210" v="31"/>
          <ac:picMkLst>
            <pc:docMk/>
            <pc:sldMk cId="3452512847" sldId="256"/>
            <ac:picMk id="9" creationId="{9B5D402E-60F3-BD88-1B6C-744BF83F36CC}"/>
          </ac:picMkLst>
        </pc:picChg>
        <pc:picChg chg="add mod">
          <ac:chgData name="Dominik Aumann" userId="013c187a20e8f01a" providerId="LiveId" clId="{08600B58-B2E9-4E2C-A90B-BCD813464593}" dt="2024-02-26T00:45:21.210" v="31"/>
          <ac:picMkLst>
            <pc:docMk/>
            <pc:sldMk cId="3452512847" sldId="256"/>
            <ac:picMk id="15" creationId="{B57E8B83-5A97-8C15-6A82-DA72E8C3B9BC}"/>
          </ac:picMkLst>
        </pc:picChg>
        <pc:picChg chg="del mod">
          <ac:chgData name="Dominik Aumann" userId="013c187a20e8f01a" providerId="LiveId" clId="{08600B58-B2E9-4E2C-A90B-BCD813464593}" dt="2024-02-26T00:47:19.476" v="68" actId="478"/>
          <ac:picMkLst>
            <pc:docMk/>
            <pc:sldMk cId="3452512847" sldId="256"/>
            <ac:picMk id="16" creationId="{00000000-0000-0000-0000-000000000000}"/>
          </ac:picMkLst>
        </pc:picChg>
        <pc:picChg chg="add del mod">
          <ac:chgData name="Dominik Aumann" userId="013c187a20e8f01a" providerId="LiveId" clId="{08600B58-B2E9-4E2C-A90B-BCD813464593}" dt="2024-02-26T00:47:43.832" v="77" actId="478"/>
          <ac:picMkLst>
            <pc:docMk/>
            <pc:sldMk cId="3452512847" sldId="256"/>
            <ac:picMk id="20" creationId="{00000000-0000-0000-0000-000000000000}"/>
          </ac:picMkLst>
        </pc:picChg>
        <pc:picChg chg="add del mod">
          <ac:chgData name="Dominik Aumann" userId="013c187a20e8f01a" providerId="LiveId" clId="{08600B58-B2E9-4E2C-A90B-BCD813464593}" dt="2024-02-26T00:45:39.987" v="38" actId="1076"/>
          <ac:picMkLst>
            <pc:docMk/>
            <pc:sldMk cId="3452512847" sldId="256"/>
            <ac:picMk id="22" creationId="{B6AE6EC0-E484-BC18-70F1-026FEB49726C}"/>
          </ac:picMkLst>
        </pc:picChg>
        <pc:picChg chg="add mod">
          <ac:chgData name="Dominik Aumann" userId="013c187a20e8f01a" providerId="LiveId" clId="{08600B58-B2E9-4E2C-A90B-BCD813464593}" dt="2024-02-26T00:45:36.253" v="35"/>
          <ac:picMkLst>
            <pc:docMk/>
            <pc:sldMk cId="3452512847" sldId="256"/>
            <ac:picMk id="27" creationId="{B6AE6EC0-E484-BC18-70F1-026FEB49726C}"/>
          </ac:picMkLst>
        </pc:picChg>
        <pc:picChg chg="add del mod">
          <ac:chgData name="Dominik Aumann" userId="013c187a20e8f01a" providerId="LiveId" clId="{08600B58-B2E9-4E2C-A90B-BCD813464593}" dt="2024-02-26T00:47:41.083" v="76" actId="21"/>
          <ac:picMkLst>
            <pc:docMk/>
            <pc:sldMk cId="3452512847" sldId="256"/>
            <ac:picMk id="28" creationId="{9B5D402E-60F3-BD88-1B6C-744BF83F36CC}"/>
          </ac:picMkLst>
        </pc:picChg>
        <pc:picChg chg="add del mod">
          <ac:chgData name="Dominik Aumann" userId="013c187a20e8f01a" providerId="LiveId" clId="{08600B58-B2E9-4E2C-A90B-BCD813464593}" dt="2024-02-26T00:47:17.586" v="67" actId="21"/>
          <ac:picMkLst>
            <pc:docMk/>
            <pc:sldMk cId="3452512847" sldId="256"/>
            <ac:picMk id="31" creationId="{B57E8B83-5A97-8C15-6A82-DA72E8C3B9BC}"/>
          </ac:picMkLst>
        </pc:picChg>
        <pc:picChg chg="add del mod">
          <ac:chgData name="Dominik Aumann" userId="013c187a20e8f01a" providerId="LiveId" clId="{08600B58-B2E9-4E2C-A90B-BCD813464593}" dt="2024-02-26T00:46:52.329" v="60" actId="21"/>
          <ac:picMkLst>
            <pc:docMk/>
            <pc:sldMk cId="3452512847" sldId="256"/>
            <ac:picMk id="32" creationId="{B6AE6EC0-E484-BC18-70F1-026FEB49726C}"/>
          </ac:picMkLst>
        </pc:picChg>
        <pc:picChg chg="add mod ord">
          <ac:chgData name="Dominik Aumann" userId="013c187a20e8f01a" providerId="LiveId" clId="{08600B58-B2E9-4E2C-A90B-BCD813464593}" dt="2024-02-26T00:46:57.609" v="63" actId="167"/>
          <ac:picMkLst>
            <pc:docMk/>
            <pc:sldMk cId="3452512847" sldId="256"/>
            <ac:picMk id="33" creationId="{B6AE6EC0-E484-BC18-70F1-026FEB49726C}"/>
          </ac:picMkLst>
        </pc:picChg>
        <pc:picChg chg="add mod ord">
          <ac:chgData name="Dominik Aumann" userId="013c187a20e8f01a" providerId="LiveId" clId="{08600B58-B2E9-4E2C-A90B-BCD813464593}" dt="2024-02-26T00:47:22.728" v="70" actId="167"/>
          <ac:picMkLst>
            <pc:docMk/>
            <pc:sldMk cId="3452512847" sldId="256"/>
            <ac:picMk id="34" creationId="{B57E8B83-5A97-8C15-6A82-DA72E8C3B9BC}"/>
          </ac:picMkLst>
        </pc:picChg>
        <pc:picChg chg="add mod ord">
          <ac:chgData name="Dominik Aumann" userId="013c187a20e8f01a" providerId="LiveId" clId="{08600B58-B2E9-4E2C-A90B-BCD813464593}" dt="2024-02-26T00:47:47.956" v="79" actId="167"/>
          <ac:picMkLst>
            <pc:docMk/>
            <pc:sldMk cId="3452512847" sldId="256"/>
            <ac:picMk id="78" creationId="{9B5D402E-60F3-BD88-1B6C-744BF83F36CC}"/>
          </ac:picMkLst>
        </pc:picChg>
        <pc:cxnChg chg="mod">
          <ac:chgData name="Dominik Aumann" userId="013c187a20e8f01a" providerId="LiveId" clId="{08600B58-B2E9-4E2C-A90B-BCD813464593}" dt="2024-02-26T00:49:49.224" v="100" actId="553"/>
          <ac:cxnSpMkLst>
            <pc:docMk/>
            <pc:sldMk cId="3452512847" sldId="256"/>
            <ac:cxnSpMk id="48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49:17.231" v="93" actId="552"/>
          <ac:cxnSpMkLst>
            <pc:docMk/>
            <pc:sldMk cId="3452512847" sldId="256"/>
            <ac:cxnSpMk id="49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49:27.307" v="94" actId="552"/>
          <ac:cxnSpMkLst>
            <pc:docMk/>
            <pc:sldMk cId="3452512847" sldId="256"/>
            <ac:cxnSpMk id="50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49:54.441" v="101" actId="1036"/>
          <ac:cxnSpMkLst>
            <pc:docMk/>
            <pc:sldMk cId="3452512847" sldId="256"/>
            <ac:cxnSpMk id="51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49:17.231" v="93" actId="552"/>
          <ac:cxnSpMkLst>
            <pc:docMk/>
            <pc:sldMk cId="3452512847" sldId="256"/>
            <ac:cxnSpMk id="52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49:27.307" v="94" actId="552"/>
          <ac:cxnSpMkLst>
            <pc:docMk/>
            <pc:sldMk cId="3452512847" sldId="256"/>
            <ac:cxnSpMk id="53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49:49.224" v="100" actId="553"/>
          <ac:cxnSpMkLst>
            <pc:docMk/>
            <pc:sldMk cId="3452512847" sldId="256"/>
            <ac:cxnSpMk id="71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50:10.281" v="111" actId="1037"/>
          <ac:cxnSpMkLst>
            <pc:docMk/>
            <pc:sldMk cId="3452512847" sldId="256"/>
            <ac:cxnSpMk id="80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49:17.231" v="93" actId="552"/>
          <ac:cxnSpMkLst>
            <pc:docMk/>
            <pc:sldMk cId="3452512847" sldId="256"/>
            <ac:cxnSpMk id="83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49:27.307" v="94" actId="552"/>
          <ac:cxnSpMkLst>
            <pc:docMk/>
            <pc:sldMk cId="3452512847" sldId="256"/>
            <ac:cxnSpMk id="84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50:54.833" v="145" actId="1037"/>
          <ac:cxnSpMkLst>
            <pc:docMk/>
            <pc:sldMk cId="3452512847" sldId="256"/>
            <ac:cxnSpMk id="85" creationId="{00000000-0000-0000-0000-000000000000}"/>
          </ac:cxnSpMkLst>
        </pc:cxnChg>
        <pc:cxnChg chg="mod">
          <ac:chgData name="Dominik Aumann" userId="013c187a20e8f01a" providerId="LiveId" clId="{08600B58-B2E9-4E2C-A90B-BCD813464593}" dt="2024-02-26T00:50:32.135" v="138" actId="1037"/>
          <ac:cxnSpMkLst>
            <pc:docMk/>
            <pc:sldMk cId="3452512847" sldId="256"/>
            <ac:cxnSpMk id="86" creationId="{00000000-0000-0000-0000-000000000000}"/>
          </ac:cxnSpMkLst>
        </pc:cxnChg>
      </pc:sldChg>
      <pc:sldChg chg="addSp delSp modSp new del mod">
        <pc:chgData name="Dominik Aumann" userId="013c187a20e8f01a" providerId="LiveId" clId="{08600B58-B2E9-4E2C-A90B-BCD813464593}" dt="2024-02-26T00:47:52.658" v="82" actId="47"/>
        <pc:sldMkLst>
          <pc:docMk/>
          <pc:sldMk cId="1128085394" sldId="257"/>
        </pc:sldMkLst>
        <pc:spChg chg="del">
          <ac:chgData name="Dominik Aumann" userId="013c187a20e8f01a" providerId="LiveId" clId="{08600B58-B2E9-4E2C-A90B-BCD813464593}" dt="2024-02-26T00:43:11.443" v="1" actId="478"/>
          <ac:spMkLst>
            <pc:docMk/>
            <pc:sldMk cId="1128085394" sldId="257"/>
            <ac:spMk id="2" creationId="{025E1230-139F-7795-EAAF-40C6CFD8C1C0}"/>
          </ac:spMkLst>
        </pc:spChg>
        <pc:spChg chg="del">
          <ac:chgData name="Dominik Aumann" userId="013c187a20e8f01a" providerId="LiveId" clId="{08600B58-B2E9-4E2C-A90B-BCD813464593}" dt="2024-02-26T00:43:11.443" v="1" actId="478"/>
          <ac:spMkLst>
            <pc:docMk/>
            <pc:sldMk cId="1128085394" sldId="257"/>
            <ac:spMk id="3" creationId="{2A9A2DA6-5B53-0554-8F29-FBD4075F3FB8}"/>
          </ac:spMkLst>
        </pc:spChg>
        <pc:picChg chg="add del mod">
          <ac:chgData name="Dominik Aumann" userId="013c187a20e8f01a" providerId="LiveId" clId="{08600B58-B2E9-4E2C-A90B-BCD813464593}" dt="2024-02-26T00:46:02.325" v="51" actId="21"/>
          <ac:picMkLst>
            <pc:docMk/>
            <pc:sldMk cId="1128085394" sldId="257"/>
            <ac:picMk id="5" creationId="{9B5D402E-60F3-BD88-1B6C-744BF83F36CC}"/>
          </ac:picMkLst>
        </pc:picChg>
        <pc:picChg chg="add del mod">
          <ac:chgData name="Dominik Aumann" userId="013c187a20e8f01a" providerId="LiveId" clId="{08600B58-B2E9-4E2C-A90B-BCD813464593}" dt="2024-02-26T00:43:43.998" v="18" actId="21"/>
          <ac:picMkLst>
            <pc:docMk/>
            <pc:sldMk cId="1128085394" sldId="257"/>
            <ac:picMk id="7" creationId="{438BCB85-634D-DA52-1F62-2DD8CFBFF2EA}"/>
          </ac:picMkLst>
        </pc:picChg>
        <pc:picChg chg="add del mod">
          <ac:chgData name="Dominik Aumann" userId="013c187a20e8f01a" providerId="LiveId" clId="{08600B58-B2E9-4E2C-A90B-BCD813464593}" dt="2024-02-26T00:46:02.325" v="51" actId="21"/>
          <ac:picMkLst>
            <pc:docMk/>
            <pc:sldMk cId="1128085394" sldId="257"/>
            <ac:picMk id="9" creationId="{B57E8B83-5A97-8C15-6A82-DA72E8C3B9BC}"/>
          </ac:picMkLst>
        </pc:picChg>
        <pc:picChg chg="add del mod">
          <ac:chgData name="Dominik Aumann" userId="013c187a20e8f01a" providerId="LiveId" clId="{08600B58-B2E9-4E2C-A90B-BCD813464593}" dt="2024-02-26T00:43:46.888" v="20" actId="478"/>
          <ac:picMkLst>
            <pc:docMk/>
            <pc:sldMk cId="1128085394" sldId="257"/>
            <ac:picMk id="10" creationId="{438BCB85-634D-DA52-1F62-2DD8CFBFF2EA}"/>
          </ac:picMkLst>
        </pc:picChg>
        <pc:picChg chg="add del mod">
          <ac:chgData name="Dominik Aumann" userId="013c187a20e8f01a" providerId="LiveId" clId="{08600B58-B2E9-4E2C-A90B-BCD813464593}" dt="2024-02-26T00:46:02.325" v="51" actId="21"/>
          <ac:picMkLst>
            <pc:docMk/>
            <pc:sldMk cId="1128085394" sldId="257"/>
            <ac:picMk id="12" creationId="{B6AE6EC0-E484-BC18-70F1-026FEB49726C}"/>
          </ac:picMkLst>
        </pc:picChg>
      </pc:sldChg>
      <pc:sldChg chg="addSp modSp add mod ord">
        <pc:chgData name="Dominik Aumann" userId="013c187a20e8f01a" providerId="LiveId" clId="{08600B58-B2E9-4E2C-A90B-BCD813464593}" dt="2024-02-26T00:47:51.471" v="81"/>
        <pc:sldMkLst>
          <pc:docMk/>
          <pc:sldMk cId="2769504502" sldId="258"/>
        </pc:sldMkLst>
        <pc:spChg chg="add mod">
          <ac:chgData name="Dominik Aumann" userId="013c187a20e8f01a" providerId="LiveId" clId="{08600B58-B2E9-4E2C-A90B-BCD813464593}" dt="2024-02-26T00:45:58.639" v="50" actId="1076"/>
          <ac:spMkLst>
            <pc:docMk/>
            <pc:sldMk cId="2769504502" sldId="258"/>
            <ac:spMk id="9" creationId="{112B59F9-3147-6723-2111-477058F31A1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080135" y="3914657"/>
            <a:ext cx="12241530" cy="2701171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2160270" y="7140892"/>
            <a:ext cx="10081260" cy="322040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715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43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145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0861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8576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6291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400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172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683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140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16444557" y="927616"/>
            <a:ext cx="5103137" cy="19757054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1135143" y="927616"/>
            <a:ext cx="15069384" cy="19757054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113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289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137643" y="8097680"/>
            <a:ext cx="12241530" cy="2502813"/>
          </a:xfrm>
        </p:spPr>
        <p:txBody>
          <a:bodyPr anchor="t"/>
          <a:lstStyle>
            <a:lvl1pPr algn="l">
              <a:defRPr sz="68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137643" y="5341086"/>
            <a:ext cx="12241530" cy="2756594"/>
          </a:xfrm>
        </p:spPr>
        <p:txBody>
          <a:bodyPr anchor="b"/>
          <a:lstStyle>
            <a:lvl1pPr marL="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1pPr>
            <a:lvl2pPr marL="771525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54305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31457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30861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85762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62915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540067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6172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81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1135142" y="5402343"/>
            <a:ext cx="10086261" cy="15282328"/>
          </a:xfrm>
        </p:spPr>
        <p:txBody>
          <a:bodyPr/>
          <a:lstStyle>
            <a:lvl1pPr>
              <a:defRPr sz="4700"/>
            </a:lvl1pPr>
            <a:lvl2pPr>
              <a:defRPr sz="4100"/>
            </a:lvl2pPr>
            <a:lvl3pPr>
              <a:defRPr sz="34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11461433" y="5402343"/>
            <a:ext cx="10086261" cy="15282328"/>
          </a:xfrm>
        </p:spPr>
        <p:txBody>
          <a:bodyPr/>
          <a:lstStyle>
            <a:lvl1pPr>
              <a:defRPr sz="4700"/>
            </a:lvl1pPr>
            <a:lvl2pPr>
              <a:defRPr sz="4100"/>
            </a:lvl2pPr>
            <a:lvl3pPr>
              <a:defRPr sz="34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6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0090" y="504647"/>
            <a:ext cx="12961620" cy="2100263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0090" y="2820770"/>
            <a:ext cx="6363296" cy="1175563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71525" indent="0">
              <a:buNone/>
              <a:defRPr sz="3400" b="1"/>
            </a:lvl2pPr>
            <a:lvl3pPr marL="1543050" indent="0">
              <a:buNone/>
              <a:defRPr sz="3000" b="1"/>
            </a:lvl3pPr>
            <a:lvl4pPr marL="2314575" indent="0">
              <a:buNone/>
              <a:defRPr sz="2700" b="1"/>
            </a:lvl4pPr>
            <a:lvl5pPr marL="3086100" indent="0">
              <a:buNone/>
              <a:defRPr sz="2700" b="1"/>
            </a:lvl5pPr>
            <a:lvl6pPr marL="3857625" indent="0">
              <a:buNone/>
              <a:defRPr sz="2700" b="1"/>
            </a:lvl6pPr>
            <a:lvl7pPr marL="4629150" indent="0">
              <a:buNone/>
              <a:defRPr sz="2700" b="1"/>
            </a:lvl7pPr>
            <a:lvl8pPr marL="5400675" indent="0">
              <a:buNone/>
              <a:defRPr sz="2700" b="1"/>
            </a:lvl8pPr>
            <a:lvl9pPr marL="6172200" indent="0">
              <a:buNone/>
              <a:defRPr sz="27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720090" y="3996333"/>
            <a:ext cx="6363296" cy="7260492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7315915" y="2820770"/>
            <a:ext cx="6365796" cy="1175563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71525" indent="0">
              <a:buNone/>
              <a:defRPr sz="3400" b="1"/>
            </a:lvl2pPr>
            <a:lvl3pPr marL="1543050" indent="0">
              <a:buNone/>
              <a:defRPr sz="3000" b="1"/>
            </a:lvl3pPr>
            <a:lvl4pPr marL="2314575" indent="0">
              <a:buNone/>
              <a:defRPr sz="2700" b="1"/>
            </a:lvl4pPr>
            <a:lvl5pPr marL="3086100" indent="0">
              <a:buNone/>
              <a:defRPr sz="2700" b="1"/>
            </a:lvl5pPr>
            <a:lvl6pPr marL="3857625" indent="0">
              <a:buNone/>
              <a:defRPr sz="2700" b="1"/>
            </a:lvl6pPr>
            <a:lvl7pPr marL="4629150" indent="0">
              <a:buNone/>
              <a:defRPr sz="2700" b="1"/>
            </a:lvl7pPr>
            <a:lvl8pPr marL="5400675" indent="0">
              <a:buNone/>
              <a:defRPr sz="2700" b="1"/>
            </a:lvl8pPr>
            <a:lvl9pPr marL="6172200" indent="0">
              <a:buNone/>
              <a:defRPr sz="27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7315915" y="3996333"/>
            <a:ext cx="6365796" cy="7260492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508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640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515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0091" y="501729"/>
            <a:ext cx="4738093" cy="2135267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630704" y="501730"/>
            <a:ext cx="8051006" cy="10755095"/>
          </a:xfrm>
        </p:spPr>
        <p:txBody>
          <a:bodyPr/>
          <a:lstStyle>
            <a:lvl1pPr>
              <a:defRPr sz="5400"/>
            </a:lvl1pPr>
            <a:lvl2pPr>
              <a:defRPr sz="4700"/>
            </a:lvl2pPr>
            <a:lvl3pPr>
              <a:defRPr sz="41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720091" y="2636997"/>
            <a:ext cx="4738093" cy="8619828"/>
          </a:xfrm>
        </p:spPr>
        <p:txBody>
          <a:bodyPr/>
          <a:lstStyle>
            <a:lvl1pPr marL="0" indent="0">
              <a:buNone/>
              <a:defRPr sz="2400"/>
            </a:lvl1pPr>
            <a:lvl2pPr marL="771525" indent="0">
              <a:buNone/>
              <a:defRPr sz="2000"/>
            </a:lvl2pPr>
            <a:lvl3pPr marL="1543050" indent="0">
              <a:buNone/>
              <a:defRPr sz="1700"/>
            </a:lvl3pPr>
            <a:lvl4pPr marL="2314575" indent="0">
              <a:buNone/>
              <a:defRPr sz="1500"/>
            </a:lvl4pPr>
            <a:lvl5pPr marL="3086100" indent="0">
              <a:buNone/>
              <a:defRPr sz="1500"/>
            </a:lvl5pPr>
            <a:lvl6pPr marL="3857625" indent="0">
              <a:buNone/>
              <a:defRPr sz="1500"/>
            </a:lvl6pPr>
            <a:lvl7pPr marL="4629150" indent="0">
              <a:buNone/>
              <a:defRPr sz="1500"/>
            </a:lvl7pPr>
            <a:lvl8pPr marL="5400675" indent="0">
              <a:buNone/>
              <a:defRPr sz="1500"/>
            </a:lvl8pPr>
            <a:lvl9pPr marL="6172200" indent="0">
              <a:buNone/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922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822854" y="8821103"/>
            <a:ext cx="8641080" cy="1041381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822854" y="1125974"/>
            <a:ext cx="8641080" cy="7560945"/>
          </a:xfrm>
        </p:spPr>
        <p:txBody>
          <a:bodyPr/>
          <a:lstStyle>
            <a:lvl1pPr marL="0" indent="0">
              <a:buNone/>
              <a:defRPr sz="5400"/>
            </a:lvl1pPr>
            <a:lvl2pPr marL="771525" indent="0">
              <a:buNone/>
              <a:defRPr sz="4700"/>
            </a:lvl2pPr>
            <a:lvl3pPr marL="1543050" indent="0">
              <a:buNone/>
              <a:defRPr sz="4100"/>
            </a:lvl3pPr>
            <a:lvl4pPr marL="2314575" indent="0">
              <a:buNone/>
              <a:defRPr sz="3400"/>
            </a:lvl4pPr>
            <a:lvl5pPr marL="3086100" indent="0">
              <a:buNone/>
              <a:defRPr sz="3400"/>
            </a:lvl5pPr>
            <a:lvl6pPr marL="3857625" indent="0">
              <a:buNone/>
              <a:defRPr sz="3400"/>
            </a:lvl6pPr>
            <a:lvl7pPr marL="4629150" indent="0">
              <a:buNone/>
              <a:defRPr sz="3400"/>
            </a:lvl7pPr>
            <a:lvl8pPr marL="5400675" indent="0">
              <a:buNone/>
              <a:defRPr sz="3400"/>
            </a:lvl8pPr>
            <a:lvl9pPr marL="6172200" indent="0">
              <a:buNone/>
              <a:defRPr sz="34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822854" y="9862484"/>
            <a:ext cx="8641080" cy="1478934"/>
          </a:xfrm>
        </p:spPr>
        <p:txBody>
          <a:bodyPr/>
          <a:lstStyle>
            <a:lvl1pPr marL="0" indent="0">
              <a:buNone/>
              <a:defRPr sz="2400"/>
            </a:lvl1pPr>
            <a:lvl2pPr marL="771525" indent="0">
              <a:buNone/>
              <a:defRPr sz="2000"/>
            </a:lvl2pPr>
            <a:lvl3pPr marL="1543050" indent="0">
              <a:buNone/>
              <a:defRPr sz="1700"/>
            </a:lvl3pPr>
            <a:lvl4pPr marL="2314575" indent="0">
              <a:buNone/>
              <a:defRPr sz="1500"/>
            </a:lvl4pPr>
            <a:lvl5pPr marL="3086100" indent="0">
              <a:buNone/>
              <a:defRPr sz="1500"/>
            </a:lvl5pPr>
            <a:lvl6pPr marL="3857625" indent="0">
              <a:buNone/>
              <a:defRPr sz="1500"/>
            </a:lvl6pPr>
            <a:lvl7pPr marL="4629150" indent="0">
              <a:buNone/>
              <a:defRPr sz="1500"/>
            </a:lvl7pPr>
            <a:lvl8pPr marL="5400675" indent="0">
              <a:buNone/>
              <a:defRPr sz="1500"/>
            </a:lvl8pPr>
            <a:lvl9pPr marL="6172200" indent="0">
              <a:buNone/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811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720090" y="504647"/>
            <a:ext cx="12961620" cy="2100263"/>
          </a:xfrm>
          <a:prstGeom prst="rect">
            <a:avLst/>
          </a:prstGeom>
        </p:spPr>
        <p:txBody>
          <a:bodyPr vert="horz" lIns="154305" tIns="77153" rIns="154305" bIns="77153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0090" y="2940368"/>
            <a:ext cx="12961620" cy="8316457"/>
          </a:xfrm>
          <a:prstGeom prst="rect">
            <a:avLst/>
          </a:prstGeom>
        </p:spPr>
        <p:txBody>
          <a:bodyPr vert="horz" lIns="154305" tIns="77153" rIns="154305" bIns="77153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720090" y="11679794"/>
            <a:ext cx="3360420" cy="670917"/>
          </a:xfrm>
          <a:prstGeom prst="rect">
            <a:avLst/>
          </a:prstGeom>
        </p:spPr>
        <p:txBody>
          <a:bodyPr vert="horz" lIns="154305" tIns="77153" rIns="154305" bIns="77153" rtlCol="0" anchor="ctr"/>
          <a:lstStyle>
            <a:lvl1pPr algn="l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C742C-42D9-4202-BB9D-0A2646F874E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920615" y="11679794"/>
            <a:ext cx="4560570" cy="670917"/>
          </a:xfrm>
          <a:prstGeom prst="rect">
            <a:avLst/>
          </a:prstGeom>
        </p:spPr>
        <p:txBody>
          <a:bodyPr vert="horz" lIns="154305" tIns="77153" rIns="154305" bIns="77153" rtlCol="0" anchor="ctr"/>
          <a:lstStyle>
            <a:lvl1pPr algn="ct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10321290" y="11679794"/>
            <a:ext cx="3360420" cy="670917"/>
          </a:xfrm>
          <a:prstGeom prst="rect">
            <a:avLst/>
          </a:prstGeom>
        </p:spPr>
        <p:txBody>
          <a:bodyPr vert="horz" lIns="154305" tIns="77153" rIns="154305" bIns="77153" rtlCol="0" anchor="ctr"/>
          <a:lstStyle>
            <a:lvl1pPr algn="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CBD3B-BB15-4C04-A3D5-7B6CD96E82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877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543050" rtl="0" eaLnBrk="1" latinLnBrk="0" hangingPunct="1">
        <a:spcBef>
          <a:spcPct val="0"/>
        </a:spcBef>
        <a:buNone/>
        <a:defRPr sz="7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8644" indent="-578644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253728" indent="-482203" algn="l" defTabSz="1543050" rtl="0" eaLnBrk="1" latinLnBrk="0" hangingPunct="1">
        <a:spcBef>
          <a:spcPct val="20000"/>
        </a:spcBef>
        <a:buFont typeface="Arial" panose="020B0604020202020204" pitchFamily="34" charset="0"/>
        <a:buChar char="–"/>
        <a:defRPr sz="4700" kern="1200">
          <a:solidFill>
            <a:schemeClr val="tx1"/>
          </a:solidFill>
          <a:latin typeface="+mn-lt"/>
          <a:ea typeface="+mn-ea"/>
          <a:cs typeface="+mn-cs"/>
        </a:defRPr>
      </a:lvl2pPr>
      <a:lvl3pPr marL="1928813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2700338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471863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»"/>
        <a:defRPr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243388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014913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5786438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557963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71525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54305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314575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3857625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62915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400675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617220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2.png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microsoft.com/office/2007/relationships/hdphoto" Target="../media/hdphoto1.wdp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3.png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Grafik 77" descr="Ein Bild, das Text, Reihe, Screenshot, Schrift enthält.&#10;&#10;Automatisch generierte Beschreibung">
            <a:extLst>
              <a:ext uri="{FF2B5EF4-FFF2-40B4-BE49-F238E27FC236}">
                <a16:creationId xmlns="" xmlns:a16="http://schemas.microsoft.com/office/drawing/2014/main" id="{9B5D402E-60F3-BD88-1B6C-744BF83F36C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0178" y="1082719"/>
            <a:ext cx="4352400" cy="1590852"/>
          </a:xfrm>
          <a:prstGeom prst="rect">
            <a:avLst/>
          </a:prstGeom>
        </p:spPr>
      </p:pic>
      <p:pic>
        <p:nvPicPr>
          <p:cNvPr id="34" name="Grafik 33" descr="Ein Bild, das Text, Reihe, Schrift, Diagramm enthält.&#10;&#10;Automatisch generierte Beschreibung">
            <a:extLst>
              <a:ext uri="{FF2B5EF4-FFF2-40B4-BE49-F238E27FC236}">
                <a16:creationId xmlns="" xmlns:a16="http://schemas.microsoft.com/office/drawing/2014/main" id="{B57E8B83-5A97-8C15-6A82-DA72E8C3B9B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0004" y="1082719"/>
            <a:ext cx="4352400" cy="1590852"/>
          </a:xfrm>
          <a:prstGeom prst="rect">
            <a:avLst/>
          </a:prstGeom>
        </p:spPr>
      </p:pic>
      <p:pic>
        <p:nvPicPr>
          <p:cNvPr id="33" name="Grafik 32" descr="Ein Bild, das Text, Reihe, Schrift, Screenshot enthält.&#10;&#10;Automatisch generierte Beschreibung">
            <a:extLst>
              <a:ext uri="{FF2B5EF4-FFF2-40B4-BE49-F238E27FC236}">
                <a16:creationId xmlns="" xmlns:a16="http://schemas.microsoft.com/office/drawing/2014/main" id="{B6AE6EC0-E484-BC18-70F1-026FEB49726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366" y="1073171"/>
            <a:ext cx="4352400" cy="1590852"/>
          </a:xfrm>
          <a:prstGeom prst="rect">
            <a:avLst/>
          </a:prstGeom>
        </p:spPr>
      </p:pic>
      <p:pic>
        <p:nvPicPr>
          <p:cNvPr id="65" name="Grafik 6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09011" y="7476630"/>
            <a:ext cx="4392330" cy="1646978"/>
          </a:xfrm>
          <a:prstGeom prst="rect">
            <a:avLst/>
          </a:prstGeom>
        </p:spPr>
      </p:pic>
      <p:pic>
        <p:nvPicPr>
          <p:cNvPr id="57" name="Grafik 5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3983" y="7472447"/>
            <a:ext cx="4369777" cy="1638522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406" y="7472447"/>
            <a:ext cx="4374605" cy="1640332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24835" y="3271399"/>
            <a:ext cx="4388833" cy="1645668"/>
          </a:xfrm>
          <a:prstGeom prst="rect">
            <a:avLst/>
          </a:prstGeom>
        </p:spPr>
      </p:pic>
      <p:pic>
        <p:nvPicPr>
          <p:cNvPr id="66" name="Grafik 6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0930" y="3261881"/>
            <a:ext cx="4382218" cy="1643187"/>
          </a:xfrm>
          <a:prstGeom prst="rect">
            <a:avLst/>
          </a:prstGeom>
        </p:spPr>
      </p:pic>
      <p:pic>
        <p:nvPicPr>
          <p:cNvPr id="58" name="Grafik 5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394" y="3261881"/>
            <a:ext cx="4382221" cy="1643187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5127477" y="263272"/>
            <a:ext cx="62411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000" b="1" dirty="0">
                <a:latin typeface="Consolas" panose="020B0609020204030204" pitchFamily="49" charset="0"/>
              </a:rPr>
              <a:t>SAMPLE ID050</a:t>
            </a:r>
            <a:endParaRPr lang="de-AT" sz="2000" b="1" dirty="0"/>
          </a:p>
        </p:txBody>
      </p:sp>
      <p:sp>
        <p:nvSpPr>
          <p:cNvPr id="5" name="Textfeld 4">
            <a:extLst>
              <a:ext uri="{FF2B5EF4-FFF2-40B4-BE49-F238E27FC236}">
                <a16:creationId xmlns="" xmlns:a16="http://schemas.microsoft.com/office/drawing/2014/main" id="{C05B60A2-C31A-F1F7-842C-93B0F4E1C421}"/>
              </a:ext>
            </a:extLst>
          </p:cNvPr>
          <p:cNvSpPr txBox="1"/>
          <p:nvPr/>
        </p:nvSpPr>
        <p:spPr>
          <a:xfrm>
            <a:off x="9794088" y="263272"/>
            <a:ext cx="62411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000" b="1" dirty="0">
                <a:latin typeface="Consolas" panose="020B0609020204030204" pitchFamily="49" charset="0"/>
              </a:rPr>
              <a:t>SAMPLE ID072</a:t>
            </a:r>
            <a:endParaRPr lang="de-AT" sz="2000" b="1" dirty="0"/>
          </a:p>
        </p:txBody>
      </p:sp>
      <p:sp>
        <p:nvSpPr>
          <p:cNvPr id="6" name="Textfeld 5"/>
          <p:cNvSpPr txBox="1"/>
          <p:nvPr/>
        </p:nvSpPr>
        <p:spPr>
          <a:xfrm>
            <a:off x="462607" y="263272"/>
            <a:ext cx="62411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000" b="1" dirty="0">
                <a:latin typeface="Consolas" panose="020B0609020204030204" pitchFamily="49" charset="0"/>
              </a:rPr>
              <a:t>SAMPLE ID005</a:t>
            </a:r>
            <a:endParaRPr lang="de-AT" sz="2000" b="1" dirty="0"/>
          </a:p>
        </p:txBody>
      </p:sp>
      <p:sp>
        <p:nvSpPr>
          <p:cNvPr id="7" name="Textfeld 6"/>
          <p:cNvSpPr txBox="1"/>
          <p:nvPr/>
        </p:nvSpPr>
        <p:spPr>
          <a:xfrm>
            <a:off x="3618565" y="548680"/>
            <a:ext cx="3467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1" name="Google Shape;91;p1"/>
          <p:cNvSpPr txBox="1"/>
          <p:nvPr/>
        </p:nvSpPr>
        <p:spPr>
          <a:xfrm>
            <a:off x="898738" y="767080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CGH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12" name="Google Shape;91;p1"/>
          <p:cNvSpPr txBox="1"/>
          <p:nvPr/>
        </p:nvSpPr>
        <p:spPr>
          <a:xfrm>
            <a:off x="911361" y="2910179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13" name="Google Shape;91;p1"/>
          <p:cNvSpPr txBox="1"/>
          <p:nvPr/>
        </p:nvSpPr>
        <p:spPr>
          <a:xfrm>
            <a:off x="791442" y="7145802"/>
            <a:ext cx="3734242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17" name="Google Shape;91;p1"/>
          <p:cNvSpPr txBox="1"/>
          <p:nvPr/>
        </p:nvSpPr>
        <p:spPr>
          <a:xfrm>
            <a:off x="5480210" y="768723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CGH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18" name="Google Shape;91;p1"/>
          <p:cNvSpPr txBox="1"/>
          <p:nvPr/>
        </p:nvSpPr>
        <p:spPr>
          <a:xfrm>
            <a:off x="5417156" y="2961367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19" name="Google Shape;91;p1"/>
          <p:cNvSpPr txBox="1"/>
          <p:nvPr/>
        </p:nvSpPr>
        <p:spPr>
          <a:xfrm>
            <a:off x="5475972" y="7168520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21" name="Google Shape;91;p1"/>
          <p:cNvSpPr txBox="1"/>
          <p:nvPr/>
        </p:nvSpPr>
        <p:spPr>
          <a:xfrm>
            <a:off x="9863816" y="768722"/>
            <a:ext cx="4237525" cy="2323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CGH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</a:t>
            </a:r>
            <a:r>
              <a:rPr lang="en-US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euploid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 | reported: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24" name="Google Shape;91;p1"/>
          <p:cNvSpPr txBox="1"/>
          <p:nvPr/>
        </p:nvSpPr>
        <p:spPr>
          <a:xfrm>
            <a:off x="10240784" y="2982379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25" name="Google Shape;91;p1"/>
          <p:cNvSpPr txBox="1"/>
          <p:nvPr/>
        </p:nvSpPr>
        <p:spPr>
          <a:xfrm>
            <a:off x="10139109" y="7168520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4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26" name="Google Shape;91;p1"/>
          <p:cNvSpPr txBox="1"/>
          <p:nvPr/>
        </p:nvSpPr>
        <p:spPr>
          <a:xfrm>
            <a:off x="792188" y="9520063"/>
            <a:ext cx="3734242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de-DE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de-DE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Chr1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30" name="Google Shape;91;p1"/>
          <p:cNvSpPr txBox="1"/>
          <p:nvPr/>
        </p:nvSpPr>
        <p:spPr>
          <a:xfrm>
            <a:off x="5472708" y="9520063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Chr2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144556" y="725724"/>
            <a:ext cx="404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a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108038" y="2887221"/>
            <a:ext cx="404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b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84581" y="7103115"/>
            <a:ext cx="404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d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90817" y="9443537"/>
            <a:ext cx="404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e</a:t>
            </a:r>
          </a:p>
        </p:txBody>
      </p:sp>
      <p:sp>
        <p:nvSpPr>
          <p:cNvPr id="42" name="Google Shape;91;p1"/>
          <p:cNvSpPr txBox="1"/>
          <p:nvPr/>
        </p:nvSpPr>
        <p:spPr>
          <a:xfrm>
            <a:off x="517688" y="3320892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de-DE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332652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45" name="Google Shape;91;p1"/>
          <p:cNvSpPr txBox="1"/>
          <p:nvPr/>
        </p:nvSpPr>
        <p:spPr>
          <a:xfrm>
            <a:off x="549105" y="7539169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de-DE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300000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46" name="Google Shape;91;p1"/>
          <p:cNvSpPr txBox="1"/>
          <p:nvPr/>
        </p:nvSpPr>
        <p:spPr>
          <a:xfrm>
            <a:off x="5184676" y="7503703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de-DE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300000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47" name="Google Shape;91;p1"/>
          <p:cNvSpPr txBox="1"/>
          <p:nvPr/>
        </p:nvSpPr>
        <p:spPr>
          <a:xfrm>
            <a:off x="9863816" y="7507570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de-DE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300000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cxnSp>
        <p:nvCxnSpPr>
          <p:cNvPr id="48" name="Gerade Verbindung mit Pfeil 47"/>
          <p:cNvCxnSpPr>
            <a:cxnSpLocks/>
          </p:cNvCxnSpPr>
          <p:nvPr/>
        </p:nvCxnSpPr>
        <p:spPr>
          <a:xfrm flipH="1" flipV="1">
            <a:off x="853927" y="4554912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>
            <a:cxnSpLocks/>
          </p:cNvCxnSpPr>
          <p:nvPr/>
        </p:nvCxnSpPr>
        <p:spPr>
          <a:xfrm flipH="1" flipV="1">
            <a:off x="5616724" y="4356571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>
            <a:cxnSpLocks/>
          </p:cNvCxnSpPr>
          <p:nvPr/>
        </p:nvCxnSpPr>
        <p:spPr>
          <a:xfrm flipH="1" flipV="1">
            <a:off x="11729245" y="4506111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>
            <a:cxnSpLocks/>
          </p:cNvCxnSpPr>
          <p:nvPr/>
        </p:nvCxnSpPr>
        <p:spPr>
          <a:xfrm flipH="1" flipV="1">
            <a:off x="853927" y="8806931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>
            <a:cxnSpLocks/>
          </p:cNvCxnSpPr>
          <p:nvPr/>
        </p:nvCxnSpPr>
        <p:spPr>
          <a:xfrm flipH="1" flipV="1">
            <a:off x="5616724" y="8640102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mit Pfeil 52"/>
          <p:cNvCxnSpPr>
            <a:cxnSpLocks/>
          </p:cNvCxnSpPr>
          <p:nvPr/>
        </p:nvCxnSpPr>
        <p:spPr>
          <a:xfrm flipH="1" flipV="1">
            <a:off x="11729245" y="8634808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111"/>
          <p:cNvSpPr txBox="1"/>
          <p:nvPr/>
        </p:nvSpPr>
        <p:spPr>
          <a:xfrm rot="16200000">
            <a:off x="-209727" y="1753355"/>
            <a:ext cx="1223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55" name="Textfeld 120"/>
          <p:cNvSpPr txBox="1"/>
          <p:nvPr/>
        </p:nvSpPr>
        <p:spPr>
          <a:xfrm>
            <a:off x="1063331" y="2607889"/>
            <a:ext cx="3102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59" name="Textfeld 111"/>
          <p:cNvSpPr txBox="1"/>
          <p:nvPr/>
        </p:nvSpPr>
        <p:spPr>
          <a:xfrm rot="16200000">
            <a:off x="4400061" y="1772352"/>
            <a:ext cx="1223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60" name="Textfeld 120"/>
          <p:cNvSpPr txBox="1"/>
          <p:nvPr/>
        </p:nvSpPr>
        <p:spPr>
          <a:xfrm>
            <a:off x="5673119" y="2626886"/>
            <a:ext cx="3102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61" name="Textfeld 111"/>
          <p:cNvSpPr txBox="1"/>
          <p:nvPr/>
        </p:nvSpPr>
        <p:spPr>
          <a:xfrm rot="16200000">
            <a:off x="9134196" y="1752456"/>
            <a:ext cx="1223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62" name="Textfeld 120"/>
          <p:cNvSpPr txBox="1"/>
          <p:nvPr/>
        </p:nvSpPr>
        <p:spPr>
          <a:xfrm>
            <a:off x="10407254" y="2606990"/>
            <a:ext cx="3102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1042174" y="4833060"/>
            <a:ext cx="30824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 rot="16200000">
            <a:off x="-200766" y="3898817"/>
            <a:ext cx="11163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29" name="Google Shape;91;p1"/>
          <p:cNvSpPr txBox="1"/>
          <p:nvPr/>
        </p:nvSpPr>
        <p:spPr>
          <a:xfrm>
            <a:off x="5472708" y="5201447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Chr2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43" name="Google Shape;91;p1"/>
          <p:cNvSpPr txBox="1"/>
          <p:nvPr/>
        </p:nvSpPr>
        <p:spPr>
          <a:xfrm>
            <a:off x="5166346" y="3339038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en-US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1136286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5705063" y="4833060"/>
            <a:ext cx="30824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 rot="16200000">
            <a:off x="4453865" y="3911576"/>
            <a:ext cx="11163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44" name="Google Shape;91;p1"/>
          <p:cNvSpPr txBox="1"/>
          <p:nvPr/>
        </p:nvSpPr>
        <p:spPr>
          <a:xfrm>
            <a:off x="9889060" y="3306791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en-US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867739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10417320" y="4845819"/>
            <a:ext cx="30824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 rot="16200000">
            <a:off x="9156031" y="3866570"/>
            <a:ext cx="11163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092"/>
          <a:stretch/>
        </p:blipFill>
        <p:spPr>
          <a:xfrm>
            <a:off x="60556" y="5449213"/>
            <a:ext cx="4868173" cy="1513412"/>
          </a:xfrm>
          <a:prstGeom prst="rect">
            <a:avLst/>
          </a:prstGeom>
        </p:spPr>
      </p:pic>
      <p:sp>
        <p:nvSpPr>
          <p:cNvPr id="39" name="Textfeld 38"/>
          <p:cNvSpPr txBox="1"/>
          <p:nvPr/>
        </p:nvSpPr>
        <p:spPr>
          <a:xfrm>
            <a:off x="108037" y="5145836"/>
            <a:ext cx="404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c</a:t>
            </a:r>
          </a:p>
        </p:txBody>
      </p:sp>
      <p:cxnSp>
        <p:nvCxnSpPr>
          <p:cNvPr id="71" name="Gerade Verbindung mit Pfeil 70"/>
          <p:cNvCxnSpPr>
            <a:cxnSpLocks/>
          </p:cNvCxnSpPr>
          <p:nvPr/>
        </p:nvCxnSpPr>
        <p:spPr>
          <a:xfrm flipH="1" flipV="1">
            <a:off x="853927" y="2470227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481" r="1913"/>
          <a:stretch/>
        </p:blipFill>
        <p:spPr>
          <a:xfrm>
            <a:off x="9410298" y="5386449"/>
            <a:ext cx="4847386" cy="1566183"/>
          </a:xfrm>
          <a:prstGeom prst="rect">
            <a:avLst/>
          </a:prstGeom>
        </p:spPr>
      </p:pic>
      <p:sp>
        <p:nvSpPr>
          <p:cNvPr id="35" name="Google Shape;91;p1"/>
          <p:cNvSpPr txBox="1"/>
          <p:nvPr/>
        </p:nvSpPr>
        <p:spPr>
          <a:xfrm>
            <a:off x="10192466" y="5201447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Chr7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56" name="Google Shape;91;p1"/>
          <p:cNvSpPr txBox="1"/>
          <p:nvPr/>
        </p:nvSpPr>
        <p:spPr>
          <a:xfrm>
            <a:off x="840669" y="5213502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de-DE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de-DE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Chr1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1083674" y="9068603"/>
            <a:ext cx="30824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 rot="16200000">
            <a:off x="-165445" y="8175958"/>
            <a:ext cx="11163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5702650" y="9067730"/>
            <a:ext cx="30824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 rot="16200000">
            <a:off x="4485950" y="8157778"/>
            <a:ext cx="11163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10425229" y="9067730"/>
            <a:ext cx="30824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 rot="16200000">
            <a:off x="9120477" y="8149265"/>
            <a:ext cx="11163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pic>
        <p:nvPicPr>
          <p:cNvPr id="79" name="Grafik 78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108"/>
          <a:stretch/>
        </p:blipFill>
        <p:spPr>
          <a:xfrm>
            <a:off x="86834" y="9803928"/>
            <a:ext cx="4846538" cy="1488207"/>
          </a:xfrm>
          <a:prstGeom prst="rect">
            <a:avLst/>
          </a:prstGeom>
        </p:spPr>
      </p:pic>
      <p:pic>
        <p:nvPicPr>
          <p:cNvPr id="81" name="Grafik 80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9" t="19983" r="2984"/>
          <a:stretch/>
        </p:blipFill>
        <p:spPr>
          <a:xfrm>
            <a:off x="4789615" y="9812869"/>
            <a:ext cx="4686046" cy="1479266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0" t="21930" r="2701"/>
          <a:stretch/>
        </p:blipFill>
        <p:spPr>
          <a:xfrm>
            <a:off x="4859486" y="5508699"/>
            <a:ext cx="4572463" cy="1419322"/>
          </a:xfrm>
          <a:prstGeom prst="rect">
            <a:avLst/>
          </a:prstGeom>
        </p:spPr>
      </p:pic>
      <p:pic>
        <p:nvPicPr>
          <p:cNvPr id="82" name="Grafik 81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0" t="19809" r="2023"/>
          <a:stretch/>
        </p:blipFill>
        <p:spPr>
          <a:xfrm>
            <a:off x="9411734" y="9804951"/>
            <a:ext cx="4747625" cy="1483978"/>
          </a:xfrm>
          <a:prstGeom prst="rect">
            <a:avLst/>
          </a:prstGeom>
        </p:spPr>
      </p:pic>
      <p:sp>
        <p:nvSpPr>
          <p:cNvPr id="36" name="Google Shape;91;p1"/>
          <p:cNvSpPr txBox="1"/>
          <p:nvPr/>
        </p:nvSpPr>
        <p:spPr>
          <a:xfrm>
            <a:off x="10225236" y="9539415"/>
            <a:ext cx="3532133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en-US" sz="14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Chr7</a:t>
            </a:r>
            <a:endParaRPr sz="14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cxnSp>
        <p:nvCxnSpPr>
          <p:cNvPr id="83" name="Gerade Verbindung mit Pfeil 82"/>
          <p:cNvCxnSpPr>
            <a:cxnSpLocks/>
          </p:cNvCxnSpPr>
          <p:nvPr/>
        </p:nvCxnSpPr>
        <p:spPr>
          <a:xfrm flipH="1" flipV="1">
            <a:off x="5616724" y="2196331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Gerade Verbindung mit Pfeil 83"/>
          <p:cNvCxnSpPr>
            <a:cxnSpLocks/>
          </p:cNvCxnSpPr>
          <p:nvPr/>
        </p:nvCxnSpPr>
        <p:spPr>
          <a:xfrm flipH="1" flipV="1">
            <a:off x="11729245" y="2196331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 Verbindung 79"/>
          <p:cNvCxnSpPr/>
          <p:nvPr/>
        </p:nvCxnSpPr>
        <p:spPr>
          <a:xfrm flipH="1">
            <a:off x="554840" y="1928619"/>
            <a:ext cx="4261069" cy="2208"/>
          </a:xfrm>
          <a:prstGeom prst="line">
            <a:avLst/>
          </a:prstGeom>
          <a:ln w="12700">
            <a:solidFill>
              <a:srgbClr val="339E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 Verbindung 84"/>
          <p:cNvCxnSpPr/>
          <p:nvPr/>
        </p:nvCxnSpPr>
        <p:spPr>
          <a:xfrm flipH="1">
            <a:off x="5154196" y="1939345"/>
            <a:ext cx="4261069" cy="2208"/>
          </a:xfrm>
          <a:prstGeom prst="line">
            <a:avLst/>
          </a:prstGeom>
          <a:ln w="12700">
            <a:solidFill>
              <a:srgbClr val="339E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 Verbindung 85"/>
          <p:cNvCxnSpPr/>
          <p:nvPr/>
        </p:nvCxnSpPr>
        <p:spPr>
          <a:xfrm flipH="1">
            <a:off x="9878887" y="1939740"/>
            <a:ext cx="4261069" cy="2208"/>
          </a:xfrm>
          <a:prstGeom prst="line">
            <a:avLst/>
          </a:prstGeom>
          <a:ln w="12700">
            <a:solidFill>
              <a:srgbClr val="339E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feld 1"/>
          <p:cNvSpPr txBox="1"/>
          <p:nvPr/>
        </p:nvSpPr>
        <p:spPr>
          <a:xfrm>
            <a:off x="12601500" y="153195"/>
            <a:ext cx="15244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dirty="0"/>
              <a:t>Suppl. Fig 3</a:t>
            </a:r>
          </a:p>
        </p:txBody>
      </p:sp>
      <p:pic>
        <p:nvPicPr>
          <p:cNvPr id="88" name="Picture 2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3510" y="11522075"/>
            <a:ext cx="4354781" cy="75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9" name="Gerade Verbindung mit Pfeil 88"/>
          <p:cNvCxnSpPr>
            <a:cxnSpLocks/>
          </p:cNvCxnSpPr>
          <p:nvPr/>
        </p:nvCxnSpPr>
        <p:spPr>
          <a:xfrm flipH="1" flipV="1">
            <a:off x="10297244" y="2124323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Gerade Verbindung mit Pfeil 89"/>
          <p:cNvCxnSpPr>
            <a:cxnSpLocks/>
          </p:cNvCxnSpPr>
          <p:nvPr/>
        </p:nvCxnSpPr>
        <p:spPr>
          <a:xfrm flipH="1" flipV="1">
            <a:off x="14041660" y="2052315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Gerade Verbindung mit Pfeil 91"/>
          <p:cNvCxnSpPr>
            <a:cxnSpLocks/>
          </p:cNvCxnSpPr>
          <p:nvPr/>
        </p:nvCxnSpPr>
        <p:spPr>
          <a:xfrm flipH="1" flipV="1">
            <a:off x="10297244" y="4428579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Gerade Verbindung mit Pfeil 92"/>
          <p:cNvCxnSpPr>
            <a:cxnSpLocks/>
          </p:cNvCxnSpPr>
          <p:nvPr/>
        </p:nvCxnSpPr>
        <p:spPr>
          <a:xfrm flipH="1" flipV="1">
            <a:off x="14031391" y="4140547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Gerade Verbindung mit Pfeil 93"/>
          <p:cNvCxnSpPr>
            <a:cxnSpLocks/>
          </p:cNvCxnSpPr>
          <p:nvPr/>
        </p:nvCxnSpPr>
        <p:spPr>
          <a:xfrm flipH="1" flipV="1">
            <a:off x="10221914" y="8640102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Gerade Verbindung mit Pfeil 94"/>
          <p:cNvCxnSpPr>
            <a:cxnSpLocks/>
          </p:cNvCxnSpPr>
          <p:nvPr/>
        </p:nvCxnSpPr>
        <p:spPr>
          <a:xfrm flipH="1" flipV="1">
            <a:off x="14031391" y="8389019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5251284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</Words>
  <Application>Microsoft Office PowerPoint</Application>
  <PresentationFormat>Benutzerdefiniert</PresentationFormat>
  <Paragraphs>4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lvia</dc:creator>
  <cp:lastModifiedBy>Vivienne</cp:lastModifiedBy>
  <cp:revision>26</cp:revision>
  <dcterms:created xsi:type="dcterms:W3CDTF">2023-10-30T07:57:54Z</dcterms:created>
  <dcterms:modified xsi:type="dcterms:W3CDTF">2024-02-26T13:08:54Z</dcterms:modified>
</cp:coreProperties>
</file>